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0" d="100"/>
          <a:sy n="60" d="100"/>
        </p:scale>
        <p:origin x="72" y="12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FCE3F6-5FD2-7790-F134-F7C75C7D35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355291-ADA9-3B0E-7CB0-FBEA8369F7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BB81C-00E4-5F10-8EC2-DE394B891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F2D22C-6982-2CA1-BAA4-488964538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25EC2F-CCAA-7203-C1BD-51CD3DC10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23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E12F1-CD1F-7A5C-0649-56BE408A3F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D0E8E5-2FDF-CA5D-AC1B-99BF3CF893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A3D680-4C7D-85DE-150A-D57B92381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A362AB-E62A-67B6-4BE7-64EC184D8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6DAA7C-5BDF-611D-D717-B10543A1D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101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189908-EB22-052B-3AEB-02449985DA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AFCEAB-9FC3-C197-8C11-FEE1A78B1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2CD9DE-9BAE-A799-6AAF-5843E6B43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F27E5A-431C-7AF1-1817-02AB91609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C9731D-2407-4A2C-A186-1260842C8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52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BF0468-2E84-81F7-A56A-3FFECD7F7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CDD89D-8601-D555-68E6-27A566E735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D2B1A2-EA86-5032-146E-E6FC0944D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0D694-386D-2C8F-5664-01EA35385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D08979-6B1E-70C2-C5D1-023D2AE7A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15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E8D0BE-D67B-95DC-2046-6E52A6BC0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E35BE0-246A-8412-8CB1-6635CE1EDD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EF715-BFF2-64AE-8F47-256588F57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5F4E8-4908-0703-B743-5B8D6B261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70393C-2070-9864-31DF-82E5E753E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209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FED50-E52E-A18D-82A4-F5B70ECFA4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47ED33-1885-9D2D-33AC-013C4CB4DA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576E58-BD2A-CA3B-6A05-D8428D43AE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7481F7-44B6-8E40-DAF0-C9A57B8C4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ED200C-CE64-67D1-18E2-F29B5A4FC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EB24AA-E5D8-AD7D-41E2-CC573C3E6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295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8DCB35-A7FE-569C-91E5-0694E538B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BB406E-7533-FBBB-D43E-A1E7EB41C5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7ACE5A-A96D-9D38-2C16-32EA296BAD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461331-F8A8-770F-220F-F470088AE9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84BC0C-0D70-D7AE-03FE-0917B8023B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7AD8C0-BB8B-9E95-AAFB-AFA460596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A98744-E736-1AD8-AD4C-DA32F6CCB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B0EA85-CEDC-1B4F-23D9-D8E74F018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464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72E8E7-57FE-02E4-93CE-B78B14F76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0F2322B-9585-B47E-79FA-F9EA16215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D9BF5D-A3D5-B88A-A00A-62B675741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008019-4932-5788-159E-154D85DAD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976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D0283A-FDC4-720A-9120-21FE88345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4F5621-2123-3656-B8D1-49CD47BCB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C52C9A-D792-C719-5559-6215346FF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4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1BD6BD-E6E7-0D1E-7DFC-1221EF17B8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73E2AD-A4A1-221D-4009-604E12B3A3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5F92BA-B698-E96C-3FBE-7933632509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F5C39F-C415-AD35-2415-A1F83B9E6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13CFEB-5FD0-5D07-F93B-7058FFAE7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5E7636-E233-087A-1108-C6772074D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275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AFB055-2BB1-1C34-44E6-BF9A010C1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3A4D2E-ED31-1A0A-023F-F69CB96183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6EA884-F321-F017-3571-9652C75F6F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57EF43-22D5-1BB4-CD37-55E3D3CB7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CE9E44-3C48-080C-7B00-A785382A8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BFB723-3393-E2E0-C547-DEE216A62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783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AE3D04-DCFF-36A5-0DB8-1A712ED521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1BE270-E693-76F5-A24C-2FF466D642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E89743-6871-1E76-1933-EA0E5CD330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1BAD4-1D75-4CBB-B717-9F3F407F0A91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0E5A8-EDA4-ADDD-3E1F-E884FC54AB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FC675E-8328-0DB9-2C65-95B5EDE0C6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BF2A7-34DD-44DF-B822-82EDD850B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076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4E3B57D-D6F5-D587-2495-A7A2D6385BA9}"/>
              </a:ext>
            </a:extLst>
          </p:cNvPr>
          <p:cNvSpPr txBox="1"/>
          <p:nvPr/>
        </p:nvSpPr>
        <p:spPr>
          <a:xfrm>
            <a:off x="529390" y="281420"/>
            <a:ext cx="11101136" cy="16696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able S1: Pocket colposcopy training dataset.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training dataset is comprised of 756 unique patient visits. Diagnostic breakdown varies by screening method (Pap-positive, Visual inspection positive, and HPV positive), and there is an overall positivity rate of 24.2%. </a:t>
            </a:r>
            <a:endParaRPr lang="en-US" sz="16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21C7A60-98AD-3003-6293-FA6610C679B6}"/>
              </a:ext>
            </a:extLst>
          </p:cNvPr>
          <p:cNvGraphicFramePr>
            <a:graphicFrameLocks noGrp="1"/>
          </p:cNvGraphicFramePr>
          <p:nvPr/>
        </p:nvGraphicFramePr>
        <p:xfrm>
          <a:off x="3500437" y="2330482"/>
          <a:ext cx="5191125" cy="3341624"/>
        </p:xfrm>
        <a:graphic>
          <a:graphicData uri="http://schemas.openxmlformats.org/drawingml/2006/table">
            <a:tbl>
              <a:tblPr/>
              <a:tblGrid>
                <a:gridCol w="1428925">
                  <a:extLst>
                    <a:ext uri="{9D8B030D-6E8A-4147-A177-3AD203B41FA5}">
                      <a16:colId xmlns:a16="http://schemas.microsoft.com/office/drawing/2014/main" val="1674106089"/>
                    </a:ext>
                  </a:extLst>
                </a:gridCol>
                <a:gridCol w="743041">
                  <a:extLst>
                    <a:ext uri="{9D8B030D-6E8A-4147-A177-3AD203B41FA5}">
                      <a16:colId xmlns:a16="http://schemas.microsoft.com/office/drawing/2014/main" val="3086735533"/>
                    </a:ext>
                  </a:extLst>
                </a:gridCol>
                <a:gridCol w="777335">
                  <a:extLst>
                    <a:ext uri="{9D8B030D-6E8A-4147-A177-3AD203B41FA5}">
                      <a16:colId xmlns:a16="http://schemas.microsoft.com/office/drawing/2014/main" val="3227224695"/>
                    </a:ext>
                  </a:extLst>
                </a:gridCol>
                <a:gridCol w="812899">
                  <a:extLst>
                    <a:ext uri="{9D8B030D-6E8A-4147-A177-3AD203B41FA5}">
                      <a16:colId xmlns:a16="http://schemas.microsoft.com/office/drawing/2014/main" val="3772987988"/>
                    </a:ext>
                  </a:extLst>
                </a:gridCol>
                <a:gridCol w="1428925">
                  <a:extLst>
                    <a:ext uri="{9D8B030D-6E8A-4147-A177-3AD203B41FA5}">
                      <a16:colId xmlns:a16="http://schemas.microsoft.com/office/drawing/2014/main" val="415294976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creened Pap+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298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creened VIA+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62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creened HPV+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396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l Screening Methods </a:t>
                      </a:r>
                      <a:b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</a:b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756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76972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egative colposcopy impression (no biopsy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 (2.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8 (12.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6 (19.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90 (11.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87966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iopsy Result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3202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rmal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53 (51.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 (11.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67 (42.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27 (43.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369981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bnormal</a:t>
                      </a:r>
                      <a:b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</a:b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Benign/CIN1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5 (25.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 (6.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7 (19.4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56 (20.6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2945008"/>
                  </a:ext>
                </a:extLst>
              </a:tr>
              <a:tr h="153035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High-grade </a:t>
                      </a:r>
                      <a:b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</a:b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CIN2/CIN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6 (18.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5 (56.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4 (18.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65 (21.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26587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ancer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8 (2.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8 (12.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 (0.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8 (2.4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36309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egative (&lt;CIN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34 (78.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9 (30.6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20 (80.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73 (75.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1348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ositive (≥CIN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4 (21.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3 (69.4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6 (19.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83 (24.2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12279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88745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AC5DEAB-1C8C-D5AA-037A-839E752E9889}"/>
              </a:ext>
            </a:extLst>
          </p:cNvPr>
          <p:cNvSpPr txBox="1"/>
          <p:nvPr/>
        </p:nvSpPr>
        <p:spPr>
          <a:xfrm>
            <a:off x="224589" y="97382"/>
            <a:ext cx="11245516" cy="16696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able S2: Pocket colposcopy testing dataset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testing dataset is comprised of 124 unique patient visits from patients that were not represented in the training dataset. Diagnostic breakdown varies by screening method (Pap-positive, Visual inspection positive, and HPV positive), and there is an overall positivity rate of 16.1%. </a:t>
            </a:r>
            <a:endParaRPr lang="en-US" sz="16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4A3240B-EA4E-DC84-52DE-65857AA9A340}"/>
              </a:ext>
            </a:extLst>
          </p:cNvPr>
          <p:cNvGraphicFramePr>
            <a:graphicFrameLocks noGrp="1"/>
          </p:cNvGraphicFramePr>
          <p:nvPr/>
        </p:nvGraphicFramePr>
        <p:xfrm>
          <a:off x="3500437" y="2330482"/>
          <a:ext cx="5191125" cy="3341624"/>
        </p:xfrm>
        <a:graphic>
          <a:graphicData uri="http://schemas.openxmlformats.org/drawingml/2006/table">
            <a:tbl>
              <a:tblPr/>
              <a:tblGrid>
                <a:gridCol w="1428925">
                  <a:extLst>
                    <a:ext uri="{9D8B030D-6E8A-4147-A177-3AD203B41FA5}">
                      <a16:colId xmlns:a16="http://schemas.microsoft.com/office/drawing/2014/main" val="3295320650"/>
                    </a:ext>
                  </a:extLst>
                </a:gridCol>
                <a:gridCol w="743041">
                  <a:extLst>
                    <a:ext uri="{9D8B030D-6E8A-4147-A177-3AD203B41FA5}">
                      <a16:colId xmlns:a16="http://schemas.microsoft.com/office/drawing/2014/main" val="2852813772"/>
                    </a:ext>
                  </a:extLst>
                </a:gridCol>
                <a:gridCol w="777335">
                  <a:extLst>
                    <a:ext uri="{9D8B030D-6E8A-4147-A177-3AD203B41FA5}">
                      <a16:colId xmlns:a16="http://schemas.microsoft.com/office/drawing/2014/main" val="2979288922"/>
                    </a:ext>
                  </a:extLst>
                </a:gridCol>
                <a:gridCol w="812899">
                  <a:extLst>
                    <a:ext uri="{9D8B030D-6E8A-4147-A177-3AD203B41FA5}">
                      <a16:colId xmlns:a16="http://schemas.microsoft.com/office/drawing/2014/main" val="3269334545"/>
                    </a:ext>
                  </a:extLst>
                </a:gridCol>
                <a:gridCol w="1428925">
                  <a:extLst>
                    <a:ext uri="{9D8B030D-6E8A-4147-A177-3AD203B41FA5}">
                      <a16:colId xmlns:a16="http://schemas.microsoft.com/office/drawing/2014/main" val="23292696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creened Pap+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114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creened VIA+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10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creened HPV+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0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l Screening Methods </a:t>
                      </a:r>
                      <a:b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</a:b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=880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19459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egative colposcopy impression (no biopsy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 (5.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 (4.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92857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iopsy Result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63936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rmal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8 (50.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8 (46.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149595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bnormal</a:t>
                      </a:r>
                      <a:b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</a:b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Benign/CIN1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5 (30.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 (50,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0 (32.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0940922"/>
                  </a:ext>
                </a:extLst>
              </a:tr>
              <a:tr h="153035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High-grade </a:t>
                      </a:r>
                      <a:b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</a:b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CIN2/CIN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2 (10.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 (10.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3 (10.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99033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7145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ancer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 (2.6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 (40.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 (5.6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6855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egative (&lt;CIN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99 (86.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 (50.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04 (83.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2626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ositive (≥CIN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5 (13.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0 (50.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 (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 (16.1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66110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35380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62</Words>
  <Application>Microsoft Office PowerPoint</Application>
  <PresentationFormat>Widescreen</PresentationFormat>
  <Paragraphs>9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a Skerrett</dc:creator>
  <cp:lastModifiedBy>Erica Skerrett</cp:lastModifiedBy>
  <cp:revision>1</cp:revision>
  <dcterms:created xsi:type="dcterms:W3CDTF">2022-08-03T03:16:22Z</dcterms:created>
  <dcterms:modified xsi:type="dcterms:W3CDTF">2022-08-03T03:18:26Z</dcterms:modified>
</cp:coreProperties>
</file>